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6"/>
  </p:notesMasterIdLst>
  <p:sldIdLst>
    <p:sldId id="280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5"/>
    <p:restoredTop sz="94607"/>
  </p:normalViewPr>
  <p:slideViewPr>
    <p:cSldViewPr snapToGrid="0">
      <p:cViewPr varScale="1">
        <p:scale>
          <a:sx n="102" d="100"/>
          <a:sy n="102" d="100"/>
        </p:scale>
        <p:origin x="83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12544B-A6F2-1F4B-8F86-13E973054863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F396AC-7941-C748-ADB9-D714A50D65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2228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279498-D31F-F758-05CB-A6E22908D6E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4CB30F-85D3-2921-6EFE-63A85F922BE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51C6B1-55FD-2AD1-2721-73A54454F9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F5AF32-1C79-69A7-D0EE-C86FE3E1D1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B2C8F4-A3B7-7466-8F04-50B5F0885C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1085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61CCEA-7D89-ADC4-AF2C-8A30A70AE0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BB69CA-6A0A-38C0-44E0-6EF2A2B3B1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B478AA-E1A8-D44E-68B5-D10915C741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5C0405-765C-A27D-FD41-539798176F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ACC667-4EC5-C7A3-B30B-D09981A29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84823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B88B358-B87E-E32B-6E48-FD010157EAE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7C867A-DE94-93B4-6C65-8D69DEB7DC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5A31E1-D246-AB38-AF22-95D2267131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6809E8-922F-9AD4-01D2-B5374BAF34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EFC6A7-632A-E7A3-F4AE-25FA3424EB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0710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C0C5D0-57CE-7D58-D292-3EEA76E926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A8E1E0-208B-9446-5BAC-7F7BCAE9F83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450727-5171-866F-51E2-A85EF49112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35C5A3-63EC-9BD3-43EF-E7C4BC8CA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99CC52-108A-955A-EB51-351C352931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1231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50CADB-D0EA-C104-3C60-F12371F3FA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9E59C8-AFC8-15CA-6D6C-2B9A4B899C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BA1384-F098-2417-11C9-5027759854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B48F47-E5A9-E723-3E86-7F470931E9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791CA7-2772-CAE5-B49E-D00FF11CCF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3634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920A7F-2B7F-BF6F-271D-4A1934ECF2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D6F1CA-4E89-EF36-CC82-111CE0FCAF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9C4AD5-F7A7-0100-FB10-350AD31A71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923709-2403-A360-DFE1-3CFB4955C4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CC7687-D011-A6AA-CCCD-9AF534926B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1FA1FA-5266-D085-D8D7-D255C18043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7469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A3F355-6BEF-CA03-0F48-477AC4C719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B902DBB-0291-C48C-9432-3E47B4A2E6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7B2E92E-EEBC-58AE-6086-3133CF7CA6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DA68868-64D6-A4A4-131D-3FDA4B527B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3595EE1-CC0D-73D7-2D81-45ABFD248D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199AF04-BE69-D741-8391-5726BD44A9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8D98E95-0C52-16C9-0071-5FF4143C6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CD04686-2EDF-952F-5367-9F73A91D98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112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045017-1B50-0AD6-42EB-D9F8990714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9C793E-6733-F8DA-E035-454FFB9CB6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6D6A689-9A8C-85E0-B8E3-27C530DB8B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45EFF38-3E42-4508-336C-16619048FD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9444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6D48CDB-0542-6A9F-DA38-A77E7854D5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5F90CA6-1974-5C60-93D7-1A01192FA8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A23A7A4-DE28-5AE5-2260-8E86771EBF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6186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23347-6552-3127-2217-49CC8B3180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4467FA-4EE8-BF89-7FBD-E4D559980D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45F8B4-94A6-8DF0-DC76-0D106D56B4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3C6296-8941-B7A1-3844-0C3061675A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038C1E9-A1CE-0C6F-EE19-4EAB151DDE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87B011-7973-86F0-C670-5922316177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494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2DE216-9B04-93E9-2BE6-2DE0133F85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54FF562-77F6-59E8-0286-7069D2180D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F3BA97-0BEE-607C-3ED9-B652B68E25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28BEAB-D618-2172-DAF0-862EB148E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4C941D-F639-544D-830B-B13D7D2966E3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6623EE-BC6A-8C35-A4DC-57C0AA76A8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4B7CC09-3C13-BECF-D4B4-C35BF4AF7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31916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EF674F9-5395-C8B0-67B7-F97957AD22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0E98DF-7876-74F4-4787-ABCCC5A2D3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BB59CA-522A-B345-5F05-F7E8DDA5478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4C941D-F639-544D-830B-B13D7D2966E3}" type="datetimeFigureOut">
              <a:rPr lang="en-US" smtClean="0"/>
              <a:t>6/10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3C0A5F-9CB5-A9D3-AD4E-991B72DABDD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76B226-9837-270F-C720-0B10437034F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BC218F-6715-284F-96B6-CB8B5DAF4E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190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382473B0-3569-639D-CDD4-CEF522AE3780}"/>
              </a:ext>
            </a:extLst>
          </p:cNvPr>
          <p:cNvGrpSpPr/>
          <p:nvPr/>
        </p:nvGrpSpPr>
        <p:grpSpPr>
          <a:xfrm>
            <a:off x="1927159" y="245100"/>
            <a:ext cx="7100464" cy="5946942"/>
            <a:chOff x="1943783" y="0"/>
            <a:chExt cx="7744083" cy="6429080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A0EA8EC6-7F3F-F7A6-E0B4-6B598B86A91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573473" y="2563679"/>
              <a:ext cx="555484" cy="1059427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3317DC2B-9220-2356-3B0C-272DBF6527C5}"/>
                </a:ext>
              </a:extLst>
            </p:cNvPr>
            <p:cNvSpPr txBox="1"/>
            <p:nvPr/>
          </p:nvSpPr>
          <p:spPr>
            <a:xfrm>
              <a:off x="8573474" y="2163569"/>
              <a:ext cx="1114392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earson Coefficient</a:t>
              </a:r>
            </a:p>
          </p:txBody>
        </p: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F70E235A-435A-89BD-18A7-0808AB69B509}"/>
                </a:ext>
              </a:extLst>
            </p:cNvPr>
            <p:cNvGrpSpPr/>
            <p:nvPr/>
          </p:nvGrpSpPr>
          <p:grpSpPr>
            <a:xfrm>
              <a:off x="1943783" y="0"/>
              <a:ext cx="6464926" cy="6429080"/>
              <a:chOff x="1679833" y="0"/>
              <a:chExt cx="6730242" cy="6750056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718B1750-E314-E1CC-AC7D-FEC5BF4319A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r="5503" b="1728"/>
              <a:stretch/>
            </p:blipFill>
            <p:spPr>
              <a:xfrm>
                <a:off x="1679833" y="0"/>
                <a:ext cx="6730242" cy="6015789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84201481-ABC2-4A21-24BB-C483E13C11D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t="2568" r="89449" b="1727"/>
              <a:stretch/>
            </p:blipFill>
            <p:spPr>
              <a:xfrm rot="16200000">
                <a:off x="5023224" y="3402276"/>
                <a:ext cx="761163" cy="5934397"/>
              </a:xfrm>
              <a:prstGeom prst="rect">
                <a:avLst/>
              </a:prstGeom>
            </p:spPr>
          </p:pic>
        </p:grp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737C7222-45D1-5724-14C4-26CCD6A50BE9}"/>
                </a:ext>
              </a:extLst>
            </p:cNvPr>
            <p:cNvSpPr/>
            <p:nvPr/>
          </p:nvSpPr>
          <p:spPr>
            <a:xfrm>
              <a:off x="2670724" y="142875"/>
              <a:ext cx="3550967" cy="348023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753A6410-8C3B-1373-C701-D75DF9F45516}"/>
                </a:ext>
              </a:extLst>
            </p:cNvPr>
            <p:cNvSpPr/>
            <p:nvPr/>
          </p:nvSpPr>
          <p:spPr>
            <a:xfrm>
              <a:off x="6555939" y="3963996"/>
              <a:ext cx="1790539" cy="1740115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37529E26-A91B-D416-EA0E-66A21619D10B}"/>
              </a:ext>
            </a:extLst>
          </p:cNvPr>
          <p:cNvSpPr txBox="1"/>
          <p:nvPr/>
        </p:nvSpPr>
        <p:spPr>
          <a:xfrm>
            <a:off x="1954777" y="6049853"/>
            <a:ext cx="6504495" cy="86177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dirty="0"/>
              <a:t>Supplementary Figure 2. Pearson correlation analysis of clinical NRS scores of itch intensity at baseline and mRNA levels of non-lesional skin biopsies. 2 major correlation clusters are outlined in red. Th17 (S100As), Th1 (CXCL9, CXCL10), Th2 (IL-13, CCL11), Itch (IL31), and General inflammation (MMP12) markers were significantly associated and clustered. +P&lt;0.1. *P&lt;0.05. **P&lt;0.01. ***P&lt;0.001. CCL, chemokine ligand; CXCL, chemokine (C-X-C motif) ligand; IL, interleukin; MMP12, matrix metalloproteinase-12; NRS, numeric rating scale; Th, T helper.</a:t>
            </a:r>
          </a:p>
        </p:txBody>
      </p:sp>
    </p:spTree>
    <p:extLst>
      <p:ext uri="{BB962C8B-B14F-4D97-AF65-F5344CB8AC3E}">
        <p14:creationId xmlns:p14="http://schemas.microsoft.com/office/powerpoint/2010/main" val="17524074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48e0ab68-5cae-4c34-92ae-33d58f8675e5">
      <Terms xmlns="http://schemas.microsoft.com/office/infopath/2007/PartnerControls"/>
    </lcf76f155ced4ddcb4097134ff3c332f>
    <TaxCatchAll xmlns="a25aac7e-bdeb-479a-95a9-91489ea9020e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C260F567E83CA4B9516D13471114631" ma:contentTypeVersion="17" ma:contentTypeDescription="Create a new document." ma:contentTypeScope="" ma:versionID="c1fbd6289b629488467ef37102a322cb">
  <xsd:schema xmlns:xsd="http://www.w3.org/2001/XMLSchema" xmlns:xs="http://www.w3.org/2001/XMLSchema" xmlns:p="http://schemas.microsoft.com/office/2006/metadata/properties" xmlns:ns2="48e0ab68-5cae-4c34-92ae-33d58f8675e5" xmlns:ns3="a25aac7e-bdeb-479a-95a9-91489ea9020e" targetNamespace="http://schemas.microsoft.com/office/2006/metadata/properties" ma:root="true" ma:fieldsID="1cb45fd8ad8bae3faad346a218767fa8" ns2:_="" ns3:_="">
    <xsd:import namespace="48e0ab68-5cae-4c34-92ae-33d58f8675e5"/>
    <xsd:import namespace="a25aac7e-bdeb-479a-95a9-91489ea9020e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DateTaken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3:SharedWithUsers" minOccurs="0"/>
                <xsd:element ref="ns3:SharedWithDetails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8e0ab68-5cae-4c34-92ae-33d58f8675e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Length (seconds)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c2180d27-daa2-489f-be1a-46b0e90a7ab3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25aac7e-bdeb-479a-95a9-91489ea9020e" elementFormDefault="qualified">
    <xsd:import namespace="http://schemas.microsoft.com/office/2006/documentManagement/types"/>
    <xsd:import namespace="http://schemas.microsoft.com/office/infopath/2007/PartnerControls"/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7f3278fd-a32d-484e-b5f2-429d4195481e}" ma:internalName="TaxCatchAll" ma:showField="CatchAllData" ma:web="a25aac7e-bdeb-479a-95a9-91489ea9020e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1BE8F78B-AE47-40A6-8936-82222647ED4C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D6B06CA0-0221-4104-82F6-A3AE4FD80E09}">
  <ds:schemaRefs>
    <ds:schemaRef ds:uri="48e0ab68-5cae-4c34-92ae-33d58f8675e5"/>
    <ds:schemaRef ds:uri="http://purl.org/dc/dcmitype/"/>
    <ds:schemaRef ds:uri="http://schemas.microsoft.com/office/2006/documentManagement/types"/>
    <ds:schemaRef ds:uri="http://purl.org/dc/terms/"/>
    <ds:schemaRef ds:uri="http://schemas.microsoft.com/office/infopath/2007/PartnerControls"/>
    <ds:schemaRef ds:uri="http://schemas.openxmlformats.org/package/2006/metadata/core-properties"/>
    <ds:schemaRef ds:uri="a25aac7e-bdeb-479a-95a9-91489ea9020e"/>
    <ds:schemaRef ds:uri="http://schemas.microsoft.com/office/2006/metadata/properties"/>
    <ds:schemaRef ds:uri="http://www.w3.org/XML/1998/namespace"/>
    <ds:schemaRef ds:uri="http://purl.org/dc/elements/1.1/"/>
  </ds:schemaRefs>
</ds:datastoreItem>
</file>

<file path=customXml/itemProps3.xml><?xml version="1.0" encoding="utf-8"?>
<ds:datastoreItem xmlns:ds="http://schemas.openxmlformats.org/officeDocument/2006/customXml" ds:itemID="{307239F4-1793-4577-9FB1-D1B98A3D184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8e0ab68-5cae-4c34-92ae-33d58f8675e5"/>
    <ds:schemaRef ds:uri="a25aac7e-bdeb-479a-95a9-91489ea9020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6712</TotalTime>
  <Words>122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deline Kim</dc:creator>
  <cp:lastModifiedBy>JoAnn Clair</cp:lastModifiedBy>
  <cp:revision>100</cp:revision>
  <dcterms:created xsi:type="dcterms:W3CDTF">2023-08-23T13:59:38Z</dcterms:created>
  <dcterms:modified xsi:type="dcterms:W3CDTF">2025-06-10T14:20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6C260F567E83CA4B9516D13471114631</vt:lpwstr>
  </property>
  <property fmtid="{D5CDD505-2E9C-101B-9397-08002B2CF9AE}" pid="3" name="MediaServiceImageTags">
    <vt:lpwstr/>
  </property>
</Properties>
</file>